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75" r:id="rId3"/>
    <p:sldId id="256" r:id="rId4"/>
    <p:sldId id="279" r:id="rId5"/>
    <p:sldId id="278" r:id="rId6"/>
    <p:sldId id="277" r:id="rId7"/>
    <p:sldId id="27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7CF1977-1FCC-4A2E-9F74-EA5C2A74ECB5}" v="1" dt="2021-10-04T22:14:28.5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derrahman Ouattas" userId="7959bb79-f300-494d-8ad7-0c5e5c1c112d" providerId="ADAL" clId="{D7CF1977-1FCC-4A2E-9F74-EA5C2A74ECB5}"/>
    <pc:docChg chg="modSld">
      <pc:chgData name="Abderrahman Ouattas" userId="7959bb79-f300-494d-8ad7-0c5e5c1c112d" providerId="ADAL" clId="{D7CF1977-1FCC-4A2E-9F74-EA5C2A74ECB5}" dt="2021-10-04T22:13:59.338" v="80"/>
      <pc:docMkLst>
        <pc:docMk/>
      </pc:docMkLst>
      <pc:sldChg chg="modSp mod">
        <pc:chgData name="Abderrahman Ouattas" userId="7959bb79-f300-494d-8ad7-0c5e5c1c112d" providerId="ADAL" clId="{D7CF1977-1FCC-4A2E-9F74-EA5C2A74ECB5}" dt="2021-10-04T22:13:08.379" v="46" actId="20577"/>
        <pc:sldMkLst>
          <pc:docMk/>
          <pc:sldMk cId="1230906041" sldId="256"/>
        </pc:sldMkLst>
        <pc:spChg chg="mod">
          <ac:chgData name="Abderrahman Ouattas" userId="7959bb79-f300-494d-8ad7-0c5e5c1c112d" providerId="ADAL" clId="{D7CF1977-1FCC-4A2E-9F74-EA5C2A74ECB5}" dt="2021-10-04T22:13:08.379" v="46" actId="20577"/>
          <ac:spMkLst>
            <pc:docMk/>
            <pc:sldMk cId="1230906041" sldId="256"/>
            <ac:spMk id="5" creationId="{A72908CD-327F-48D2-BF32-F29A0797476F}"/>
          </ac:spMkLst>
        </pc:spChg>
      </pc:sldChg>
      <pc:sldChg chg="modSp mod">
        <pc:chgData name="Abderrahman Ouattas" userId="7959bb79-f300-494d-8ad7-0c5e5c1c112d" providerId="ADAL" clId="{D7CF1977-1FCC-4A2E-9F74-EA5C2A74ECB5}" dt="2021-10-04T22:12:52.660" v="30" actId="20577"/>
        <pc:sldMkLst>
          <pc:docMk/>
          <pc:sldMk cId="2936194975" sldId="275"/>
        </pc:sldMkLst>
        <pc:spChg chg="mod">
          <ac:chgData name="Abderrahman Ouattas" userId="7959bb79-f300-494d-8ad7-0c5e5c1c112d" providerId="ADAL" clId="{D7CF1977-1FCC-4A2E-9F74-EA5C2A74ECB5}" dt="2021-10-04T22:12:52.660" v="30" actId="20577"/>
          <ac:spMkLst>
            <pc:docMk/>
            <pc:sldMk cId="2936194975" sldId="275"/>
            <ac:spMk id="4" creationId="{84F94BCB-FC46-40EA-A8CC-554DA60DB133}"/>
          </ac:spMkLst>
        </pc:spChg>
      </pc:sldChg>
      <pc:sldChg chg="modSp mod">
        <pc:chgData name="Abderrahman Ouattas" userId="7959bb79-f300-494d-8ad7-0c5e5c1c112d" providerId="ADAL" clId="{D7CF1977-1FCC-4A2E-9F74-EA5C2A74ECB5}" dt="2021-10-04T22:13:59.338" v="80"/>
        <pc:sldMkLst>
          <pc:docMk/>
          <pc:sldMk cId="1089971044" sldId="276"/>
        </pc:sldMkLst>
        <pc:spChg chg="mod">
          <ac:chgData name="Abderrahman Ouattas" userId="7959bb79-f300-494d-8ad7-0c5e5c1c112d" providerId="ADAL" clId="{D7CF1977-1FCC-4A2E-9F74-EA5C2A74ECB5}" dt="2021-10-04T22:13:59.338" v="80"/>
          <ac:spMkLst>
            <pc:docMk/>
            <pc:sldMk cId="1089971044" sldId="276"/>
            <ac:spMk id="2" creationId="{6E1F1416-E324-41A6-9172-9D945EEA0A49}"/>
          </ac:spMkLst>
        </pc:spChg>
      </pc:sldChg>
      <pc:sldChg chg="modSp mod">
        <pc:chgData name="Abderrahman Ouattas" userId="7959bb79-f300-494d-8ad7-0c5e5c1c112d" providerId="ADAL" clId="{D7CF1977-1FCC-4A2E-9F74-EA5C2A74ECB5}" dt="2021-10-04T22:13:50.162" v="79"/>
        <pc:sldMkLst>
          <pc:docMk/>
          <pc:sldMk cId="486352472" sldId="277"/>
        </pc:sldMkLst>
        <pc:spChg chg="mod">
          <ac:chgData name="Abderrahman Ouattas" userId="7959bb79-f300-494d-8ad7-0c5e5c1c112d" providerId="ADAL" clId="{D7CF1977-1FCC-4A2E-9F74-EA5C2A74ECB5}" dt="2021-10-04T22:13:50.162" v="79"/>
          <ac:spMkLst>
            <pc:docMk/>
            <pc:sldMk cId="486352472" sldId="277"/>
            <ac:spMk id="2" creationId="{8964690C-968D-4076-84BD-B1275367D02B}"/>
          </ac:spMkLst>
        </pc:spChg>
      </pc:sldChg>
      <pc:sldChg chg="modSp mod">
        <pc:chgData name="Abderrahman Ouattas" userId="7959bb79-f300-494d-8ad7-0c5e5c1c112d" providerId="ADAL" clId="{D7CF1977-1FCC-4A2E-9F74-EA5C2A74ECB5}" dt="2021-10-04T22:13:38.500" v="78" actId="20577"/>
        <pc:sldMkLst>
          <pc:docMk/>
          <pc:sldMk cId="3797870689" sldId="278"/>
        </pc:sldMkLst>
        <pc:spChg chg="mod">
          <ac:chgData name="Abderrahman Ouattas" userId="7959bb79-f300-494d-8ad7-0c5e5c1c112d" providerId="ADAL" clId="{D7CF1977-1FCC-4A2E-9F74-EA5C2A74ECB5}" dt="2021-10-04T22:13:38.500" v="78" actId="20577"/>
          <ac:spMkLst>
            <pc:docMk/>
            <pc:sldMk cId="3797870689" sldId="278"/>
            <ac:spMk id="2" creationId="{029FE7C6-8A92-4C14-8D32-B668A6B8D1AC}"/>
          </ac:spMkLst>
        </pc:spChg>
      </pc:sldChg>
      <pc:sldChg chg="modSp mod">
        <pc:chgData name="Abderrahman Ouattas" userId="7959bb79-f300-494d-8ad7-0c5e5c1c112d" providerId="ADAL" clId="{D7CF1977-1FCC-4A2E-9F74-EA5C2A74ECB5}" dt="2021-10-04T22:13:30.979" v="63" actId="20577"/>
        <pc:sldMkLst>
          <pc:docMk/>
          <pc:sldMk cId="3999145117" sldId="279"/>
        </pc:sldMkLst>
        <pc:spChg chg="mod">
          <ac:chgData name="Abderrahman Ouattas" userId="7959bb79-f300-494d-8ad7-0c5e5c1c112d" providerId="ADAL" clId="{D7CF1977-1FCC-4A2E-9F74-EA5C2A74ECB5}" dt="2021-10-04T22:13:30.979" v="63" actId="20577"/>
          <ac:spMkLst>
            <pc:docMk/>
            <pc:sldMk cId="3999145117" sldId="279"/>
            <ac:spMk id="2" creationId="{E5CE2ACE-59D0-43DB-AB0A-CDDB9ED60C8C}"/>
          </ac:spMkLst>
        </pc:spChg>
      </pc:sldChg>
      <pc:sldChg chg="modSp mod">
        <pc:chgData name="Abderrahman Ouattas" userId="7959bb79-f300-494d-8ad7-0c5e5c1c112d" providerId="ADAL" clId="{D7CF1977-1FCC-4A2E-9F74-EA5C2A74ECB5}" dt="2021-10-04T22:12:25.249" v="6"/>
        <pc:sldMkLst>
          <pc:docMk/>
          <pc:sldMk cId="1521882226" sldId="280"/>
        </pc:sldMkLst>
        <pc:spChg chg="mod">
          <ac:chgData name="Abderrahman Ouattas" userId="7959bb79-f300-494d-8ad7-0c5e5c1c112d" providerId="ADAL" clId="{D7CF1977-1FCC-4A2E-9F74-EA5C2A74ECB5}" dt="2021-10-04T22:12:25.249" v="6"/>
          <ac:spMkLst>
            <pc:docMk/>
            <pc:sldMk cId="1521882226" sldId="280"/>
            <ac:spMk id="24" creationId="{C8BD2AC9-F11E-4C14-B974-E4DACEAB93D6}"/>
          </ac:spMkLst>
        </pc:spChg>
        <pc:spChg chg="mod">
          <ac:chgData name="Abderrahman Ouattas" userId="7959bb79-f300-494d-8ad7-0c5e5c1c112d" providerId="ADAL" clId="{D7CF1977-1FCC-4A2E-9F74-EA5C2A74ECB5}" dt="2021-10-04T22:12:18.554" v="4"/>
          <ac:spMkLst>
            <pc:docMk/>
            <pc:sldMk cId="1521882226" sldId="280"/>
            <ac:spMk id="25" creationId="{40B0DA75-9049-4060-891E-1B9FE8B5A5C3}"/>
          </ac:spMkLst>
        </pc:spChg>
        <pc:spChg chg="mod">
          <ac:chgData name="Abderrahman Ouattas" userId="7959bb79-f300-494d-8ad7-0c5e5c1c112d" providerId="ADAL" clId="{D7CF1977-1FCC-4A2E-9F74-EA5C2A74ECB5}" dt="2021-10-04T22:12:04.673" v="1"/>
          <ac:spMkLst>
            <pc:docMk/>
            <pc:sldMk cId="1521882226" sldId="280"/>
            <ac:spMk id="26" creationId="{C6864D30-5DE4-4DC9-A70D-43B4C2EF49A2}"/>
          </ac:spMkLst>
        </pc:spChg>
        <pc:spChg chg="mod">
          <ac:chgData name="Abderrahman Ouattas" userId="7959bb79-f300-494d-8ad7-0c5e5c1c112d" providerId="ADAL" clId="{D7CF1977-1FCC-4A2E-9F74-EA5C2A74ECB5}" dt="2021-10-04T22:11:56.002" v="0"/>
          <ac:spMkLst>
            <pc:docMk/>
            <pc:sldMk cId="1521882226" sldId="280"/>
            <ac:spMk id="27" creationId="{FA260863-3D96-4F97-B0CE-DAE93EFA648C}"/>
          </ac:spMkLst>
        </pc:spChg>
        <pc:spChg chg="mod">
          <ac:chgData name="Abderrahman Ouattas" userId="7959bb79-f300-494d-8ad7-0c5e5c1c112d" providerId="ADAL" clId="{D7CF1977-1FCC-4A2E-9F74-EA5C2A74ECB5}" dt="2021-10-04T22:12:12.401" v="3"/>
          <ac:spMkLst>
            <pc:docMk/>
            <pc:sldMk cId="1521882226" sldId="280"/>
            <ac:spMk id="90" creationId="{C1B42988-0AE5-4CA2-8720-D114C5AB006B}"/>
          </ac:spMkLst>
        </pc:spChg>
        <pc:spChg chg="mod">
          <ac:chgData name="Abderrahman Ouattas" userId="7959bb79-f300-494d-8ad7-0c5e5c1c112d" providerId="ADAL" clId="{D7CF1977-1FCC-4A2E-9F74-EA5C2A74ECB5}" dt="2021-10-04T22:12:09.113" v="2"/>
          <ac:spMkLst>
            <pc:docMk/>
            <pc:sldMk cId="1521882226" sldId="280"/>
            <ac:spMk id="91" creationId="{421AFEC6-995B-4668-A68C-161DD50C26C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9D653-1A86-4EF6-9DBE-1ED5DC4864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6CAF6D-B06C-4496-B04F-247C3645F6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D77F7E-B904-43C0-8CA6-888E1D338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2CC03B-E3E0-43D8-93A0-7B679F95C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2FD481-369A-4432-8A29-19274A9BF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088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56F2BC-F16B-4241-B0AC-5858E74F1C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E39EA0-8EA9-4371-A187-68315B3285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55449A-0F83-4929-84DC-A350C8ACC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7EC825-2DFA-4EB9-A4C5-3B6C97EE8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AE9C9-84CD-4EC1-8737-01FA73150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818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1019E1-F539-4EBB-BBE8-345CCE2D37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C141EC-FE6D-4E67-9078-0CD4CE2D48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D8201-936C-46FC-B685-5CB23DD08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527CE-8E4A-49FE-AF00-C8320D1DB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402D38-3149-441B-92ED-FFC833B0F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761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04B532-C2B1-4B2E-9C2C-0AFAC094A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1AEB35-365A-4F0E-BFBF-1AAE1A49E6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1915AD-41CE-4013-86B5-6E9FDC392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7E8523-8D18-447D-951A-9EB8EB38C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2E83D3-17AA-49E5-9A7C-5D53F07E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688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69F3C-E96B-4565-A0E5-6F3D24559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6A3072-A5AE-4FD1-825D-558DEE908B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981915-0911-4E8E-AC1E-1EF3101EA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BD6ACD-F046-4D40-8745-727E93877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3310E3-4A21-4A64-AA13-2AC0CEC2F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631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667A1D-A692-4415-AB2A-DC8B1B278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923417-EC47-4EFD-806C-1C914DAB4D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1ED586-C785-4751-8BFA-309E9C18FF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F80825-501C-4AA6-8D3D-006DFE660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220BDF-1CA3-47BB-AD22-702D4A4FC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ABE02A-9CB4-4AF9-835F-7C8F20A15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426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66088-6D95-43B2-9355-1050372403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B17F56-15D6-45E0-B9FF-BC38592104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26630C-0AD2-4A5D-AD00-50C2A3188B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562CE4-8520-406C-89BB-4882D863A5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DEDBFC-1B2A-423D-B077-A80160E7EA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78D281-915F-4B33-8817-ACEEC3879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A81C69-149B-4BAC-8E5D-4D1C72591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30FF10-771D-42A2-BC87-704EC8139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638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ABF9B-659C-4242-AEF0-23318B483E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6FF45D-FF57-4E17-B504-9A5074AAF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4DDD19-1DA2-433D-8AB1-0CA807C9F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9477B7-5202-4991-ADD7-5D7B86398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77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17C140-3C29-43B6-9918-EE7C5D866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6B3D8F-66BB-4697-AC54-810C0471C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DD2FC7-D09F-4DED-8E3E-321257B7F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698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5A4A0-8963-4714-969C-E0C06D241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CD0D6-C5CC-44B3-9530-276D5AEECA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6280EC-41FD-4D1A-BE2D-D8F1B47618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21E1DF-E5E6-48C1-AAB5-39E756CAE1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20783B-4CCE-4443-A6B4-F3685B6EA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F7096C-8E39-41ED-B830-7036AA8C6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395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FF1F9-5530-43FF-AC28-9DD0345A0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0F457C-DF21-433A-8816-0D48058498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94E0E3-5AC1-4163-AE18-824B56B93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C5354A-617F-40D5-B7F6-651D10EFC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D495AC-7CDD-4D33-9A90-76EC0C469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31D6B0-F29E-4714-8D6C-64AF6BBD9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31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B2A8EA-163B-4D9D-B58B-23CAFE9B24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3A7E68-E5BA-415E-918E-37589D4C0C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8B9D95-6100-4F6E-AB66-F351BC3D7A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3B1EA-2C09-450E-8BCD-791326EAE898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6E8973-8DE4-4BA8-90BB-CAC836EC9A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18F96A-4743-4190-AD39-DCD808C902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658F0-1C9C-4C0F-BD82-F72E0C5FD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964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6.mp4"/><Relationship Id="rId1" Type="http://schemas.microsoft.com/office/2007/relationships/media" Target="../media/media6.mp4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219D0303-D927-4F26-B109-95EE71645C48}"/>
              </a:ext>
            </a:extLst>
          </p:cNvPr>
          <p:cNvSpPr/>
          <p:nvPr/>
        </p:nvSpPr>
        <p:spPr>
          <a:xfrm>
            <a:off x="1751042" y="708033"/>
            <a:ext cx="13292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art 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B7A7E1B-02FB-411E-B513-9BA77FF6C95F}"/>
              </a:ext>
            </a:extLst>
          </p:cNvPr>
          <p:cNvSpPr/>
          <p:nvPr/>
        </p:nvSpPr>
        <p:spPr>
          <a:xfrm>
            <a:off x="1751042" y="1288513"/>
            <a:ext cx="1453971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op</a:t>
            </a:r>
            <a:endParaRPr lang="en-US" sz="1200" b="1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B37406B-5055-49CE-9526-32E7A7ADDC68}"/>
              </a:ext>
            </a:extLst>
          </p:cNvPr>
          <p:cNvSpPr/>
          <p:nvPr/>
        </p:nvSpPr>
        <p:spPr>
          <a:xfrm>
            <a:off x="1751041" y="1868498"/>
            <a:ext cx="16340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NDM ML </a:t>
            </a:r>
            <a:r>
              <a:rPr lang="en-US" sz="1200" b="1" dirty="0" err="1">
                <a:ln w="0"/>
              </a:rPr>
              <a:t>Ft</a:t>
            </a:r>
            <a:r>
              <a:rPr lang="en-US" sz="1200" b="1" baseline="-25000" dirty="0" err="1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9B9D183-CEDA-4797-A84E-9955E12F204E}"/>
              </a:ext>
            </a:extLst>
          </p:cNvPr>
          <p:cNvSpPr/>
          <p:nvPr/>
        </p:nvSpPr>
        <p:spPr>
          <a:xfrm>
            <a:off x="1751041" y="2445749"/>
            <a:ext cx="1634073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DM ML </a:t>
            </a:r>
            <a:r>
              <a:rPr lang="en-US" sz="1200" b="1" dirty="0" err="1">
                <a:ln w="0"/>
              </a:rPr>
              <a:t>Ft</a:t>
            </a:r>
            <a:r>
              <a:rPr lang="en-US" sz="1200" b="1" baseline="-25000" dirty="0" err="1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6B05742-8D18-49D3-995B-CDDA99779796}"/>
              </a:ext>
            </a:extLst>
          </p:cNvPr>
          <p:cNvSpPr/>
          <p:nvPr/>
        </p:nvSpPr>
        <p:spPr>
          <a:xfrm>
            <a:off x="1281682" y="554483"/>
            <a:ext cx="2939332" cy="23247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9228D84D-4214-40C0-B851-32ED48A5D309}"/>
              </a:ext>
            </a:extLst>
          </p:cNvPr>
          <p:cNvSpPr/>
          <p:nvPr/>
        </p:nvSpPr>
        <p:spPr>
          <a:xfrm>
            <a:off x="1375632" y="625950"/>
            <a:ext cx="223842" cy="447624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ECC3AC7E-2E2C-446B-BA25-789746114730}"/>
              </a:ext>
            </a:extLst>
          </p:cNvPr>
          <p:cNvSpPr/>
          <p:nvPr/>
        </p:nvSpPr>
        <p:spPr>
          <a:xfrm>
            <a:off x="1375632" y="1204568"/>
            <a:ext cx="223842" cy="447624"/>
          </a:xfrm>
          <a:prstGeom prst="round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9F67CF6F-B867-4132-A3B7-DAF071F519D8}"/>
              </a:ext>
            </a:extLst>
          </p:cNvPr>
          <p:cNvSpPr/>
          <p:nvPr/>
        </p:nvSpPr>
        <p:spPr>
          <a:xfrm>
            <a:off x="1378011" y="1783186"/>
            <a:ext cx="223842" cy="447624"/>
          </a:xfrm>
          <a:prstGeom prst="roundRect">
            <a:avLst/>
          </a:prstGeom>
          <a:solidFill>
            <a:srgbClr val="0FF57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4854485F-FACE-4AC2-83FA-8FDDD9601F95}"/>
              </a:ext>
            </a:extLst>
          </p:cNvPr>
          <p:cNvSpPr/>
          <p:nvPr/>
        </p:nvSpPr>
        <p:spPr>
          <a:xfrm>
            <a:off x="1375632" y="2361804"/>
            <a:ext cx="223842" cy="447624"/>
          </a:xfrm>
          <a:prstGeom prst="roundRect">
            <a:avLst/>
          </a:prstGeom>
          <a:solidFill>
            <a:srgbClr val="E800E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9BF04CC7-71D6-40D4-AA1B-04433DD6F0CB}"/>
              </a:ext>
            </a:extLst>
          </p:cNvPr>
          <p:cNvSpPr/>
          <p:nvPr/>
        </p:nvSpPr>
        <p:spPr>
          <a:xfrm>
            <a:off x="8091988" y="11729"/>
            <a:ext cx="731290" cy="659338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3600" b="1" cap="none" spc="0" dirty="0">
                <a:ln w="0"/>
                <a:solidFill>
                  <a:schemeClr val="tx1"/>
                </a:solidFill>
              </a:rPr>
              <a:t>(C)</a:t>
            </a:r>
            <a:endParaRPr lang="en-US" sz="54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8BD2AC9-F11E-4C14-B974-E4DACEAB93D6}"/>
              </a:ext>
            </a:extLst>
          </p:cNvPr>
          <p:cNvSpPr/>
          <p:nvPr/>
        </p:nvSpPr>
        <p:spPr>
          <a:xfrm>
            <a:off x="10036589" y="3336156"/>
            <a:ext cx="1181734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accent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</a:rPr>
              <a:t>Sagittal </a:t>
            </a:r>
            <a:r>
              <a:rPr lang="en-US" sz="2000" b="1" dirty="0">
                <a:ln w="0"/>
                <a:solidFill>
                  <a:schemeClr val="accent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  <a:cs typeface="Times New Roman" panose="02020603050405020304" pitchFamily="18" charset="0"/>
              </a:rPr>
              <a:t>L</a:t>
            </a:r>
            <a:endParaRPr lang="en-US" sz="3600" b="1" cap="none" spc="0" dirty="0">
              <a:ln w="0"/>
              <a:solidFill>
                <a:schemeClr val="accent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Cambria Math" panose="02040503050406030204" pitchFamily="18" charset="0"/>
              <a:ea typeface="Cambria Math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0B0DA75-9049-4060-891E-1B9FE8B5A5C3}"/>
              </a:ext>
            </a:extLst>
          </p:cNvPr>
          <p:cNvSpPr/>
          <p:nvPr/>
        </p:nvSpPr>
        <p:spPr>
          <a:xfrm>
            <a:off x="10028158" y="141343"/>
            <a:ext cx="115692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rgbClr val="A162D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</a:rPr>
              <a:t>Frontal </a:t>
            </a:r>
            <a:r>
              <a:rPr lang="en-US" sz="2000" b="1" dirty="0">
                <a:ln w="0"/>
                <a:solidFill>
                  <a:srgbClr val="A162D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  <a:cs typeface="Times New Roman" panose="02020603050405020304" pitchFamily="18" charset="0"/>
              </a:rPr>
              <a:t>L</a:t>
            </a:r>
            <a:endParaRPr lang="en-US" sz="3600" b="1" cap="none" spc="0" dirty="0">
              <a:ln w="0"/>
              <a:solidFill>
                <a:srgbClr val="A162D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Cambria Math" panose="02040503050406030204" pitchFamily="18" charset="0"/>
              <a:ea typeface="Cambria Math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6864D30-5DE4-4DC9-A70D-43B4C2EF49A2}"/>
              </a:ext>
            </a:extLst>
          </p:cNvPr>
          <p:cNvSpPr/>
          <p:nvPr/>
        </p:nvSpPr>
        <p:spPr>
          <a:xfrm>
            <a:off x="5234266" y="31093"/>
            <a:ext cx="1790875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Sagittal Ft</a:t>
            </a:r>
            <a:r>
              <a:rPr lang="en-US" sz="2000" b="1" baseline="-25000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</a:t>
            </a:r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endParaRPr lang="en-US" sz="3600" b="1" cap="none" spc="0" dirty="0">
              <a:ln w="0"/>
              <a:solidFill>
                <a:schemeClr val="accent2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A260863-3D96-4F97-B0CE-DAE93EFA648C}"/>
              </a:ext>
            </a:extLst>
          </p:cNvPr>
          <p:cNvSpPr/>
          <p:nvPr/>
        </p:nvSpPr>
        <p:spPr>
          <a:xfrm>
            <a:off x="1623049" y="31093"/>
            <a:ext cx="1709955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Frontal Ft</a:t>
            </a:r>
            <a:r>
              <a:rPr lang="en-US" sz="2000" b="1" baseline="-25000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</a:t>
            </a:r>
            <a:endParaRPr lang="en-US" sz="3600" b="1" cap="none" spc="0" baseline="-25000" dirty="0">
              <a:ln w="0"/>
              <a:solidFill>
                <a:srgbClr val="992F2F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2BE4A4B-A1D6-4165-9C23-D09C9D7E8ACB}"/>
              </a:ext>
            </a:extLst>
          </p:cNvPr>
          <p:cNvSpPr/>
          <p:nvPr/>
        </p:nvSpPr>
        <p:spPr>
          <a:xfrm>
            <a:off x="5451" y="-104878"/>
            <a:ext cx="731290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b="1" cap="none" spc="0" dirty="0">
                <a:ln w="0"/>
                <a:solidFill>
                  <a:schemeClr val="tx1"/>
                </a:solidFill>
              </a:rPr>
              <a:t>(B)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22A0824-CE79-41B9-A9FB-65C702FDA7BB}"/>
              </a:ext>
            </a:extLst>
          </p:cNvPr>
          <p:cNvSpPr/>
          <p:nvPr/>
        </p:nvSpPr>
        <p:spPr>
          <a:xfrm>
            <a:off x="1751042" y="4346769"/>
            <a:ext cx="13292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art 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F2242C-51A3-4C83-9AD6-F8E45012E63B}"/>
              </a:ext>
            </a:extLst>
          </p:cNvPr>
          <p:cNvSpPr/>
          <p:nvPr/>
        </p:nvSpPr>
        <p:spPr>
          <a:xfrm>
            <a:off x="1751042" y="4927249"/>
            <a:ext cx="1453971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op</a:t>
            </a:r>
            <a:endParaRPr lang="en-US" sz="1200" b="1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62DAE39-9076-4005-8530-1FC4F52A6529}"/>
              </a:ext>
            </a:extLst>
          </p:cNvPr>
          <p:cNvSpPr/>
          <p:nvPr/>
        </p:nvSpPr>
        <p:spPr>
          <a:xfrm>
            <a:off x="1751041" y="5507234"/>
            <a:ext cx="16340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NDM ML </a:t>
            </a:r>
            <a:r>
              <a:rPr lang="en-US" sz="1200" b="1" dirty="0" err="1">
                <a:ln w="0"/>
              </a:rPr>
              <a:t>Ft</a:t>
            </a:r>
            <a:r>
              <a:rPr lang="en-US" sz="1200" b="1" baseline="-25000" dirty="0" err="1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8529D9A1-70FA-40F4-BA9C-2010ED5781F6}"/>
              </a:ext>
            </a:extLst>
          </p:cNvPr>
          <p:cNvSpPr/>
          <p:nvPr/>
        </p:nvSpPr>
        <p:spPr>
          <a:xfrm>
            <a:off x="1751041" y="6084485"/>
            <a:ext cx="1634073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DM ML </a:t>
            </a:r>
            <a:r>
              <a:rPr lang="en-US" sz="1200" b="1" dirty="0" err="1">
                <a:ln w="0"/>
              </a:rPr>
              <a:t>Ft</a:t>
            </a:r>
            <a:r>
              <a:rPr lang="en-US" sz="1200" b="1" baseline="-25000" dirty="0" err="1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344FD810-1B4E-41B4-BF4F-52C2C1FC268C}"/>
              </a:ext>
            </a:extLst>
          </p:cNvPr>
          <p:cNvSpPr/>
          <p:nvPr/>
        </p:nvSpPr>
        <p:spPr>
          <a:xfrm>
            <a:off x="1281682" y="4193219"/>
            <a:ext cx="2939332" cy="23247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: Rounded Corners 49">
            <a:extLst>
              <a:ext uri="{FF2B5EF4-FFF2-40B4-BE49-F238E27FC236}">
                <a16:creationId xmlns:a16="http://schemas.microsoft.com/office/drawing/2014/main" id="{35D54B38-49A7-4998-A4CD-40192D9F0471}"/>
              </a:ext>
            </a:extLst>
          </p:cNvPr>
          <p:cNvSpPr/>
          <p:nvPr/>
        </p:nvSpPr>
        <p:spPr>
          <a:xfrm>
            <a:off x="1375632" y="4264686"/>
            <a:ext cx="223842" cy="447624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Rectangle: Rounded Corners 50">
            <a:extLst>
              <a:ext uri="{FF2B5EF4-FFF2-40B4-BE49-F238E27FC236}">
                <a16:creationId xmlns:a16="http://schemas.microsoft.com/office/drawing/2014/main" id="{26DEBB23-2948-4533-AECF-28B182A6F9BA}"/>
              </a:ext>
            </a:extLst>
          </p:cNvPr>
          <p:cNvSpPr/>
          <p:nvPr/>
        </p:nvSpPr>
        <p:spPr>
          <a:xfrm>
            <a:off x="1375632" y="4843304"/>
            <a:ext cx="223842" cy="447624"/>
          </a:xfrm>
          <a:prstGeom prst="round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2" name="Rectangle: Rounded Corners 51">
            <a:extLst>
              <a:ext uri="{FF2B5EF4-FFF2-40B4-BE49-F238E27FC236}">
                <a16:creationId xmlns:a16="http://schemas.microsoft.com/office/drawing/2014/main" id="{09214FCB-C609-4E30-9709-F60E85FD6DBC}"/>
              </a:ext>
            </a:extLst>
          </p:cNvPr>
          <p:cNvSpPr/>
          <p:nvPr/>
        </p:nvSpPr>
        <p:spPr>
          <a:xfrm>
            <a:off x="1378011" y="5421922"/>
            <a:ext cx="223842" cy="447624"/>
          </a:xfrm>
          <a:prstGeom prst="roundRect">
            <a:avLst/>
          </a:prstGeom>
          <a:solidFill>
            <a:srgbClr val="0FF57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Rectangle: Rounded Corners 52">
            <a:extLst>
              <a:ext uri="{FF2B5EF4-FFF2-40B4-BE49-F238E27FC236}">
                <a16:creationId xmlns:a16="http://schemas.microsoft.com/office/drawing/2014/main" id="{81189B36-D0E1-4E8D-B713-5929AC405521}"/>
              </a:ext>
            </a:extLst>
          </p:cNvPr>
          <p:cNvSpPr/>
          <p:nvPr/>
        </p:nvSpPr>
        <p:spPr>
          <a:xfrm>
            <a:off x="1375632" y="6000540"/>
            <a:ext cx="223842" cy="447624"/>
          </a:xfrm>
          <a:prstGeom prst="roundRect">
            <a:avLst/>
          </a:prstGeom>
          <a:solidFill>
            <a:srgbClr val="E800E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C07905E-53DD-4102-95D2-5C7FEBD81585}"/>
              </a:ext>
            </a:extLst>
          </p:cNvPr>
          <p:cNvSpPr/>
          <p:nvPr/>
        </p:nvSpPr>
        <p:spPr>
          <a:xfrm>
            <a:off x="5408181" y="708033"/>
            <a:ext cx="13292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art 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87757A2C-128F-4F31-98F1-802440A738AE}"/>
              </a:ext>
            </a:extLst>
          </p:cNvPr>
          <p:cNvSpPr/>
          <p:nvPr/>
        </p:nvSpPr>
        <p:spPr>
          <a:xfrm>
            <a:off x="5408181" y="1288513"/>
            <a:ext cx="1453971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op</a:t>
            </a:r>
            <a:endParaRPr lang="en-US" sz="1200" b="1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45D243DF-4F9E-461B-9D07-CE7AB447EBD0}"/>
              </a:ext>
            </a:extLst>
          </p:cNvPr>
          <p:cNvSpPr/>
          <p:nvPr/>
        </p:nvSpPr>
        <p:spPr>
          <a:xfrm>
            <a:off x="5408180" y="1868498"/>
            <a:ext cx="16340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Min NDM AP Ft</a:t>
            </a:r>
            <a:r>
              <a:rPr lang="en-US" sz="1200" b="1" baseline="-25000" dirty="0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3D158076-83A6-44FE-BB5D-4A35081A15E3}"/>
              </a:ext>
            </a:extLst>
          </p:cNvPr>
          <p:cNvSpPr/>
          <p:nvPr/>
        </p:nvSpPr>
        <p:spPr>
          <a:xfrm>
            <a:off x="5408180" y="2445749"/>
            <a:ext cx="1634073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DM AP Ft</a:t>
            </a:r>
            <a:r>
              <a:rPr lang="en-US" sz="1200" b="1" baseline="-25000" dirty="0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68910BCE-79F7-43C1-AF08-A5F1A747A0A8}"/>
              </a:ext>
            </a:extLst>
          </p:cNvPr>
          <p:cNvSpPr/>
          <p:nvPr/>
        </p:nvSpPr>
        <p:spPr>
          <a:xfrm>
            <a:off x="4938821" y="554483"/>
            <a:ext cx="2939332" cy="23247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: Rounded Corners 58">
            <a:extLst>
              <a:ext uri="{FF2B5EF4-FFF2-40B4-BE49-F238E27FC236}">
                <a16:creationId xmlns:a16="http://schemas.microsoft.com/office/drawing/2014/main" id="{B580D8A7-9C69-4AEC-A591-28DB36831981}"/>
              </a:ext>
            </a:extLst>
          </p:cNvPr>
          <p:cNvSpPr/>
          <p:nvPr/>
        </p:nvSpPr>
        <p:spPr>
          <a:xfrm>
            <a:off x="5032771" y="625950"/>
            <a:ext cx="223842" cy="447624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0" name="Rectangle: Rounded Corners 59">
            <a:extLst>
              <a:ext uri="{FF2B5EF4-FFF2-40B4-BE49-F238E27FC236}">
                <a16:creationId xmlns:a16="http://schemas.microsoft.com/office/drawing/2014/main" id="{3FEE8A5E-00B8-4A25-BB63-1464400477F7}"/>
              </a:ext>
            </a:extLst>
          </p:cNvPr>
          <p:cNvSpPr/>
          <p:nvPr/>
        </p:nvSpPr>
        <p:spPr>
          <a:xfrm>
            <a:off x="5032771" y="1204568"/>
            <a:ext cx="223842" cy="447624"/>
          </a:xfrm>
          <a:prstGeom prst="round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Rectangle: Rounded Corners 60">
            <a:extLst>
              <a:ext uri="{FF2B5EF4-FFF2-40B4-BE49-F238E27FC236}">
                <a16:creationId xmlns:a16="http://schemas.microsoft.com/office/drawing/2014/main" id="{A5E75479-6FCD-4383-9F11-0067902BBEE6}"/>
              </a:ext>
            </a:extLst>
          </p:cNvPr>
          <p:cNvSpPr/>
          <p:nvPr/>
        </p:nvSpPr>
        <p:spPr>
          <a:xfrm>
            <a:off x="5035150" y="1783186"/>
            <a:ext cx="223842" cy="447624"/>
          </a:xfrm>
          <a:prstGeom prst="roundRect">
            <a:avLst/>
          </a:prstGeom>
          <a:solidFill>
            <a:srgbClr val="0FF57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Rectangle: Rounded Corners 61">
            <a:extLst>
              <a:ext uri="{FF2B5EF4-FFF2-40B4-BE49-F238E27FC236}">
                <a16:creationId xmlns:a16="http://schemas.microsoft.com/office/drawing/2014/main" id="{6379A873-376B-42CD-9411-EFB0BFA99415}"/>
              </a:ext>
            </a:extLst>
          </p:cNvPr>
          <p:cNvSpPr/>
          <p:nvPr/>
        </p:nvSpPr>
        <p:spPr>
          <a:xfrm>
            <a:off x="5032771" y="2361804"/>
            <a:ext cx="223842" cy="447624"/>
          </a:xfrm>
          <a:prstGeom prst="roundRect">
            <a:avLst/>
          </a:prstGeom>
          <a:solidFill>
            <a:srgbClr val="E800E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B4C198F0-D7D8-435E-8ED4-85394E858A6F}"/>
              </a:ext>
            </a:extLst>
          </p:cNvPr>
          <p:cNvSpPr/>
          <p:nvPr/>
        </p:nvSpPr>
        <p:spPr>
          <a:xfrm>
            <a:off x="5408181" y="4346769"/>
            <a:ext cx="13292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art 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69A82B8F-686A-420C-8D9D-38A35285A374}"/>
              </a:ext>
            </a:extLst>
          </p:cNvPr>
          <p:cNvSpPr/>
          <p:nvPr/>
        </p:nvSpPr>
        <p:spPr>
          <a:xfrm>
            <a:off x="5408181" y="4927249"/>
            <a:ext cx="1453971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op</a:t>
            </a:r>
            <a:endParaRPr lang="en-US" sz="1200" b="1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1E5C74BC-EFBE-4010-85E7-5D230C04C4C1}"/>
              </a:ext>
            </a:extLst>
          </p:cNvPr>
          <p:cNvSpPr/>
          <p:nvPr/>
        </p:nvSpPr>
        <p:spPr>
          <a:xfrm>
            <a:off x="5408180" y="5507234"/>
            <a:ext cx="16340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Min NDM AP Ft</a:t>
            </a:r>
            <a:r>
              <a:rPr lang="en-US" sz="1200" b="1" baseline="-25000" dirty="0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C742C63C-2408-4C5C-8A22-B088D058631A}"/>
              </a:ext>
            </a:extLst>
          </p:cNvPr>
          <p:cNvSpPr/>
          <p:nvPr/>
        </p:nvSpPr>
        <p:spPr>
          <a:xfrm>
            <a:off x="5408180" y="6084485"/>
            <a:ext cx="1634073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DM AP Ft</a:t>
            </a:r>
            <a:r>
              <a:rPr lang="en-US" sz="1200" b="1" baseline="-25000" dirty="0">
                <a:ln w="0"/>
              </a:rPr>
              <a:t>v_CoM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D1AAF52B-15E0-4FAA-B51F-49F0C8E1A138}"/>
              </a:ext>
            </a:extLst>
          </p:cNvPr>
          <p:cNvSpPr/>
          <p:nvPr/>
        </p:nvSpPr>
        <p:spPr>
          <a:xfrm>
            <a:off x="4938821" y="4193219"/>
            <a:ext cx="2939332" cy="23247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: Rounded Corners 67">
            <a:extLst>
              <a:ext uri="{FF2B5EF4-FFF2-40B4-BE49-F238E27FC236}">
                <a16:creationId xmlns:a16="http://schemas.microsoft.com/office/drawing/2014/main" id="{23272950-8B76-44FA-A1B0-54EA55E9616C}"/>
              </a:ext>
            </a:extLst>
          </p:cNvPr>
          <p:cNvSpPr/>
          <p:nvPr/>
        </p:nvSpPr>
        <p:spPr>
          <a:xfrm>
            <a:off x="5032771" y="4264686"/>
            <a:ext cx="223842" cy="447624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9" name="Rectangle: Rounded Corners 68">
            <a:extLst>
              <a:ext uri="{FF2B5EF4-FFF2-40B4-BE49-F238E27FC236}">
                <a16:creationId xmlns:a16="http://schemas.microsoft.com/office/drawing/2014/main" id="{AFC7F9AA-311D-402A-8207-784D100DF8D4}"/>
              </a:ext>
            </a:extLst>
          </p:cNvPr>
          <p:cNvSpPr/>
          <p:nvPr/>
        </p:nvSpPr>
        <p:spPr>
          <a:xfrm>
            <a:off x="5032771" y="4843304"/>
            <a:ext cx="223842" cy="447624"/>
          </a:xfrm>
          <a:prstGeom prst="round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" name="Rectangle: Rounded Corners 69">
            <a:extLst>
              <a:ext uri="{FF2B5EF4-FFF2-40B4-BE49-F238E27FC236}">
                <a16:creationId xmlns:a16="http://schemas.microsoft.com/office/drawing/2014/main" id="{6F4AEDBD-7813-43AB-A030-039D74D7DD23}"/>
              </a:ext>
            </a:extLst>
          </p:cNvPr>
          <p:cNvSpPr/>
          <p:nvPr/>
        </p:nvSpPr>
        <p:spPr>
          <a:xfrm>
            <a:off x="5035150" y="5421922"/>
            <a:ext cx="223842" cy="447624"/>
          </a:xfrm>
          <a:prstGeom prst="roundRect">
            <a:avLst/>
          </a:prstGeom>
          <a:solidFill>
            <a:srgbClr val="0FF57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1" name="Rectangle: Rounded Corners 70">
            <a:extLst>
              <a:ext uri="{FF2B5EF4-FFF2-40B4-BE49-F238E27FC236}">
                <a16:creationId xmlns:a16="http://schemas.microsoft.com/office/drawing/2014/main" id="{D47CC849-6BCA-4721-8165-9E7D768F9F14}"/>
              </a:ext>
            </a:extLst>
          </p:cNvPr>
          <p:cNvSpPr/>
          <p:nvPr/>
        </p:nvSpPr>
        <p:spPr>
          <a:xfrm>
            <a:off x="5032771" y="6000540"/>
            <a:ext cx="223842" cy="447624"/>
          </a:xfrm>
          <a:prstGeom prst="roundRect">
            <a:avLst/>
          </a:prstGeom>
          <a:solidFill>
            <a:srgbClr val="E800E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8D306592-2EF4-4872-A344-6290BE3DB756}"/>
              </a:ext>
            </a:extLst>
          </p:cNvPr>
          <p:cNvSpPr/>
          <p:nvPr/>
        </p:nvSpPr>
        <p:spPr>
          <a:xfrm>
            <a:off x="9436716" y="1063919"/>
            <a:ext cx="13292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art 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590D9CEE-0AD1-47F0-BBE9-AB59AC595582}"/>
              </a:ext>
            </a:extLst>
          </p:cNvPr>
          <p:cNvSpPr/>
          <p:nvPr/>
        </p:nvSpPr>
        <p:spPr>
          <a:xfrm>
            <a:off x="9436716" y="1644399"/>
            <a:ext cx="1453971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op </a:t>
            </a:r>
            <a:endParaRPr lang="en-US" sz="1200" b="1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DF8FB6EA-ED1A-46A1-8556-6A464C4BCE53}"/>
              </a:ext>
            </a:extLst>
          </p:cNvPr>
          <p:cNvSpPr/>
          <p:nvPr/>
        </p:nvSpPr>
        <p:spPr>
          <a:xfrm>
            <a:off x="9436714" y="2224384"/>
            <a:ext cx="2404303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NDM Arm Adduction L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8CCE0763-B371-4F8B-935C-FBF5AA333477}"/>
              </a:ext>
            </a:extLst>
          </p:cNvPr>
          <p:cNvSpPr/>
          <p:nvPr/>
        </p:nvSpPr>
        <p:spPr>
          <a:xfrm>
            <a:off x="8967356" y="852403"/>
            <a:ext cx="2939332" cy="186528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: Rounded Corners 76">
            <a:extLst>
              <a:ext uri="{FF2B5EF4-FFF2-40B4-BE49-F238E27FC236}">
                <a16:creationId xmlns:a16="http://schemas.microsoft.com/office/drawing/2014/main" id="{55779AA0-8466-4221-824D-3AAA486A43C7}"/>
              </a:ext>
            </a:extLst>
          </p:cNvPr>
          <p:cNvSpPr/>
          <p:nvPr/>
        </p:nvSpPr>
        <p:spPr>
          <a:xfrm>
            <a:off x="9061306" y="981836"/>
            <a:ext cx="223842" cy="447624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8" name="Rectangle: Rounded Corners 77">
            <a:extLst>
              <a:ext uri="{FF2B5EF4-FFF2-40B4-BE49-F238E27FC236}">
                <a16:creationId xmlns:a16="http://schemas.microsoft.com/office/drawing/2014/main" id="{34B09CEA-82F3-4BC8-A94A-FDAEDF0CF916}"/>
              </a:ext>
            </a:extLst>
          </p:cNvPr>
          <p:cNvSpPr/>
          <p:nvPr/>
        </p:nvSpPr>
        <p:spPr>
          <a:xfrm>
            <a:off x="9061306" y="1560454"/>
            <a:ext cx="223842" cy="447624"/>
          </a:xfrm>
          <a:prstGeom prst="round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9" name="Rectangle: Rounded Corners 78">
            <a:extLst>
              <a:ext uri="{FF2B5EF4-FFF2-40B4-BE49-F238E27FC236}">
                <a16:creationId xmlns:a16="http://schemas.microsoft.com/office/drawing/2014/main" id="{DDFBBF83-3991-4B56-B8B7-C6BA18562E95}"/>
              </a:ext>
            </a:extLst>
          </p:cNvPr>
          <p:cNvSpPr/>
          <p:nvPr/>
        </p:nvSpPr>
        <p:spPr>
          <a:xfrm>
            <a:off x="9063685" y="2139072"/>
            <a:ext cx="223842" cy="447624"/>
          </a:xfrm>
          <a:prstGeom prst="roundRect">
            <a:avLst/>
          </a:prstGeom>
          <a:solidFill>
            <a:srgbClr val="0FF57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C1B42988-0AE5-4CA2-8720-D114C5AB006B}"/>
              </a:ext>
            </a:extLst>
          </p:cNvPr>
          <p:cNvSpPr/>
          <p:nvPr/>
        </p:nvSpPr>
        <p:spPr>
          <a:xfrm>
            <a:off x="5234266" y="3283552"/>
            <a:ext cx="1790875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Sagittal Ft</a:t>
            </a:r>
            <a:r>
              <a:rPr lang="en-US" sz="2000" b="1" baseline="-25000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</a:t>
            </a:r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endParaRPr lang="en-US" sz="3600" b="1" cap="none" spc="0" dirty="0">
              <a:ln w="0"/>
              <a:solidFill>
                <a:schemeClr val="accent2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421AFEC6-995B-4668-A68C-161DD50C26C8}"/>
              </a:ext>
            </a:extLst>
          </p:cNvPr>
          <p:cNvSpPr/>
          <p:nvPr/>
        </p:nvSpPr>
        <p:spPr>
          <a:xfrm>
            <a:off x="1623049" y="3283552"/>
            <a:ext cx="1709955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Frontal Ft</a:t>
            </a:r>
            <a:r>
              <a:rPr lang="en-US" sz="2000" b="1" baseline="-25000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</a:t>
            </a:r>
            <a:endParaRPr lang="en-US" sz="3600" b="1" cap="none" spc="0" baseline="-25000" dirty="0">
              <a:ln w="0"/>
              <a:solidFill>
                <a:srgbClr val="992F2F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569115DA-FE11-41B8-AE0B-94571B18FC88}"/>
              </a:ext>
            </a:extLst>
          </p:cNvPr>
          <p:cNvSpPr/>
          <p:nvPr/>
        </p:nvSpPr>
        <p:spPr>
          <a:xfrm>
            <a:off x="9436716" y="4569800"/>
            <a:ext cx="1329274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art 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75C22531-8E15-49CC-8D45-CD58B1626DF4}"/>
              </a:ext>
            </a:extLst>
          </p:cNvPr>
          <p:cNvSpPr/>
          <p:nvPr/>
        </p:nvSpPr>
        <p:spPr>
          <a:xfrm>
            <a:off x="9436716" y="5150280"/>
            <a:ext cx="1453971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Slip Stop</a:t>
            </a:r>
            <a:endParaRPr lang="en-US" sz="1200" b="1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1C39E3E2-26ED-46AC-A006-FFBE21A1BAC9}"/>
              </a:ext>
            </a:extLst>
          </p:cNvPr>
          <p:cNvSpPr/>
          <p:nvPr/>
        </p:nvSpPr>
        <p:spPr>
          <a:xfrm>
            <a:off x="9436714" y="5730265"/>
            <a:ext cx="1922215" cy="276999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r>
              <a:rPr lang="en-US" sz="1200" b="1" dirty="0">
                <a:ln w="0"/>
              </a:rPr>
              <a:t>Peak Trunk Extension L</a:t>
            </a:r>
            <a:endParaRPr lang="en-US" sz="1200" b="1" cap="none" spc="0" baseline="-25000" dirty="0">
              <a:ln w="0"/>
              <a:solidFill>
                <a:schemeClr val="tx1"/>
              </a:solidFill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4F7BD8D6-9AD1-40DD-B0F5-4FF557039660}"/>
              </a:ext>
            </a:extLst>
          </p:cNvPr>
          <p:cNvSpPr/>
          <p:nvPr/>
        </p:nvSpPr>
        <p:spPr>
          <a:xfrm>
            <a:off x="8967356" y="4358284"/>
            <a:ext cx="2939332" cy="186528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: Rounded Corners 95">
            <a:extLst>
              <a:ext uri="{FF2B5EF4-FFF2-40B4-BE49-F238E27FC236}">
                <a16:creationId xmlns:a16="http://schemas.microsoft.com/office/drawing/2014/main" id="{F5EE231C-39D0-4CE7-A868-7853DD11040D}"/>
              </a:ext>
            </a:extLst>
          </p:cNvPr>
          <p:cNvSpPr/>
          <p:nvPr/>
        </p:nvSpPr>
        <p:spPr>
          <a:xfrm>
            <a:off x="9061306" y="4487717"/>
            <a:ext cx="223842" cy="447624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7" name="Rectangle: Rounded Corners 96">
            <a:extLst>
              <a:ext uri="{FF2B5EF4-FFF2-40B4-BE49-F238E27FC236}">
                <a16:creationId xmlns:a16="http://schemas.microsoft.com/office/drawing/2014/main" id="{D4A959DE-DF0E-48F2-A950-8BEEE7332AAE}"/>
              </a:ext>
            </a:extLst>
          </p:cNvPr>
          <p:cNvSpPr/>
          <p:nvPr/>
        </p:nvSpPr>
        <p:spPr>
          <a:xfrm>
            <a:off x="9061306" y="5066335"/>
            <a:ext cx="223842" cy="447624"/>
          </a:xfrm>
          <a:prstGeom prst="round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8" name="Rectangle: Rounded Corners 97">
            <a:extLst>
              <a:ext uri="{FF2B5EF4-FFF2-40B4-BE49-F238E27FC236}">
                <a16:creationId xmlns:a16="http://schemas.microsoft.com/office/drawing/2014/main" id="{DE6A336E-F1C5-4255-8FB9-E6AFF037D619}"/>
              </a:ext>
            </a:extLst>
          </p:cNvPr>
          <p:cNvSpPr/>
          <p:nvPr/>
        </p:nvSpPr>
        <p:spPr>
          <a:xfrm>
            <a:off x="9063685" y="5644953"/>
            <a:ext cx="223842" cy="447624"/>
          </a:xfrm>
          <a:prstGeom prst="roundRect">
            <a:avLst/>
          </a:prstGeom>
          <a:solidFill>
            <a:srgbClr val="0FF57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DA872F03-BC2B-47A2-A538-A144B3A2943B}"/>
              </a:ext>
            </a:extLst>
          </p:cNvPr>
          <p:cNvSpPr/>
          <p:nvPr/>
        </p:nvSpPr>
        <p:spPr>
          <a:xfrm>
            <a:off x="98019" y="1560454"/>
            <a:ext cx="1091773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plit-Feet</a:t>
            </a:r>
            <a:endParaRPr lang="en-US" sz="3200" b="1" cap="none" spc="0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EA0B7741-1569-4F2F-9E5D-2DF25447FAFD}"/>
              </a:ext>
            </a:extLst>
          </p:cNvPr>
          <p:cNvSpPr/>
          <p:nvPr/>
        </p:nvSpPr>
        <p:spPr>
          <a:xfrm>
            <a:off x="0" y="5651093"/>
            <a:ext cx="1300164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liding-Feet</a:t>
            </a:r>
            <a:endParaRPr lang="en-US" sz="3200" b="1" cap="none" spc="0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521882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4F94BCB-FC46-40EA-A8CC-554DA60DB133}"/>
              </a:ext>
            </a:extLst>
          </p:cNvPr>
          <p:cNvSpPr/>
          <p:nvPr/>
        </p:nvSpPr>
        <p:spPr>
          <a:xfrm>
            <a:off x="4660930" y="248899"/>
            <a:ext cx="2870146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Frontal Ft</a:t>
            </a:r>
            <a:r>
              <a:rPr lang="en-US" sz="2000" b="1" baseline="-25000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 </a:t>
            </a:r>
            <a:r>
              <a:rPr lang="en-US" sz="2000" b="1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; Split Feet</a:t>
            </a:r>
            <a:endParaRPr lang="en-US" sz="3600" b="1" cap="none" spc="0" baseline="-25000" dirty="0">
              <a:ln w="0"/>
              <a:solidFill>
                <a:srgbClr val="992F2F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pic>
        <p:nvPicPr>
          <p:cNvPr id="5" name="ML_FTv_COM_Split_Feet_s003_s1_T2">
            <a:hlinkClick r:id="" action="ppaction://media"/>
            <a:extLst>
              <a:ext uri="{FF2B5EF4-FFF2-40B4-BE49-F238E27FC236}">
                <a16:creationId xmlns:a16="http://schemas.microsoft.com/office/drawing/2014/main" id="{37E0E34D-A17C-44AA-9385-D01AC58790A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90675" y="1186705"/>
            <a:ext cx="10810650" cy="551089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3A25A8A7-DE65-40E2-B173-39B0AB7281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87844" y="39349"/>
            <a:ext cx="1704156" cy="1350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61949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534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L_FTv_COM_Sliding_Feet_s002_s1_T2">
            <a:hlinkClick r:id="" action="ppaction://media"/>
            <a:extLst>
              <a:ext uri="{FF2B5EF4-FFF2-40B4-BE49-F238E27FC236}">
                <a16:creationId xmlns:a16="http://schemas.microsoft.com/office/drawing/2014/main" id="{869BB3F3-01F9-4FD7-9387-7C69E2610CA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812800" y="1222714"/>
            <a:ext cx="10566400" cy="538638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72908CD-327F-48D2-BF32-F29A0797476F}"/>
              </a:ext>
            </a:extLst>
          </p:cNvPr>
          <p:cNvSpPr/>
          <p:nvPr/>
        </p:nvSpPr>
        <p:spPr>
          <a:xfrm>
            <a:off x="4535093" y="248899"/>
            <a:ext cx="3121817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Frontal Ft</a:t>
            </a:r>
            <a:r>
              <a:rPr lang="en-US" sz="2000" b="1" baseline="-25000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 </a:t>
            </a:r>
            <a:r>
              <a:rPr lang="en-US" sz="2000" b="1" dirty="0">
                <a:ln w="0"/>
                <a:solidFill>
                  <a:srgbClr val="992F2F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; Sliding Feet</a:t>
            </a:r>
            <a:endParaRPr lang="en-US" sz="3600" b="1" cap="none" spc="0" baseline="-25000" dirty="0">
              <a:ln w="0"/>
              <a:solidFill>
                <a:srgbClr val="992F2F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B612F48-7EB2-47C4-B356-32D642839F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18618" y="46084"/>
            <a:ext cx="1773382" cy="1405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09060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334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5CE2ACE-59D0-43DB-AB0A-CDDB9ED60C8C}"/>
              </a:ext>
            </a:extLst>
          </p:cNvPr>
          <p:cNvSpPr/>
          <p:nvPr/>
        </p:nvSpPr>
        <p:spPr>
          <a:xfrm>
            <a:off x="4638904" y="248899"/>
            <a:ext cx="2914196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Sagittal Ft</a:t>
            </a:r>
            <a:r>
              <a:rPr lang="en-US" sz="2000" b="1" baseline="-25000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</a:t>
            </a:r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 ; Split Feet</a:t>
            </a:r>
            <a:endParaRPr lang="en-US" sz="3600" b="1" cap="none" spc="0" dirty="0">
              <a:ln w="0"/>
              <a:solidFill>
                <a:schemeClr val="accent2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pic>
        <p:nvPicPr>
          <p:cNvPr id="3" name="AP_FTv_COM_Split_Feet_s111_s1_T1">
            <a:hlinkClick r:id="" action="ppaction://media"/>
            <a:extLst>
              <a:ext uri="{FF2B5EF4-FFF2-40B4-BE49-F238E27FC236}">
                <a16:creationId xmlns:a16="http://schemas.microsoft.com/office/drawing/2014/main" id="{BE73CAE3-61DB-42BE-AC27-E1A84EF0986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82171" y="982832"/>
            <a:ext cx="10827657" cy="551956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80F9FE3-8488-41FE-8663-477804BE93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05718" y="0"/>
            <a:ext cx="1586282" cy="1257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14511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4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29FE7C6-8A92-4C14-8D32-B668A6B8D1AC}"/>
              </a:ext>
            </a:extLst>
          </p:cNvPr>
          <p:cNvSpPr/>
          <p:nvPr/>
        </p:nvSpPr>
        <p:spPr>
          <a:xfrm>
            <a:off x="4513068" y="248899"/>
            <a:ext cx="3165867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Sagittal Ft</a:t>
            </a:r>
            <a:r>
              <a:rPr lang="en-US" sz="2000" b="1" baseline="-25000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v_CoM</a:t>
            </a:r>
            <a:r>
              <a:rPr lang="en-US" sz="2000" b="1" dirty="0">
                <a:ln w="0"/>
                <a:solidFill>
                  <a:schemeClr val="accent2"/>
                </a:solidFill>
                <a:latin typeface="Cambria Math" panose="02040503050406030204" pitchFamily="18" charset="0"/>
                <a:ea typeface="Cambria Math" panose="02040503050406030204" pitchFamily="18" charset="0"/>
              </a:rPr>
              <a:t> ; Sliding Feet</a:t>
            </a:r>
            <a:endParaRPr lang="en-US" sz="3600" b="1" cap="none" spc="0" dirty="0">
              <a:ln w="0"/>
              <a:solidFill>
                <a:schemeClr val="accent2"/>
              </a:solidFill>
              <a:latin typeface="Cambria Math" panose="02040503050406030204" pitchFamily="18" charset="0"/>
              <a:ea typeface="Cambria Math" panose="02040503050406030204" pitchFamily="18" charset="0"/>
            </a:endParaRPr>
          </a:p>
        </p:txBody>
      </p:sp>
      <p:pic>
        <p:nvPicPr>
          <p:cNvPr id="3" name="AP_FTv_COM_Sliding_Feet_s012_s1_T4">
            <a:hlinkClick r:id="" action="ppaction://media"/>
            <a:extLst>
              <a:ext uri="{FF2B5EF4-FFF2-40B4-BE49-F238E27FC236}">
                <a16:creationId xmlns:a16="http://schemas.microsoft.com/office/drawing/2014/main" id="{69933C59-CB08-4E46-BFBC-DED0136D27A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885761" y="1146629"/>
            <a:ext cx="10420478" cy="531200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E141170-4BB9-488D-B5A1-78D5D5ED49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05718" y="20359"/>
            <a:ext cx="1586282" cy="1257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78706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4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964690C-968D-4076-84BD-B1275367D02B}"/>
              </a:ext>
            </a:extLst>
          </p:cNvPr>
          <p:cNvSpPr/>
          <p:nvPr/>
        </p:nvSpPr>
        <p:spPr>
          <a:xfrm>
            <a:off x="5517540" y="248899"/>
            <a:ext cx="115692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rgbClr val="A162D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</a:rPr>
              <a:t>Frontal </a:t>
            </a:r>
            <a:r>
              <a:rPr lang="en-US" sz="2000" b="1" dirty="0">
                <a:ln w="0"/>
                <a:solidFill>
                  <a:srgbClr val="A162D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  <a:cs typeface="Times New Roman" panose="02020603050405020304" pitchFamily="18" charset="0"/>
              </a:rPr>
              <a:t>L</a:t>
            </a:r>
            <a:endParaRPr lang="en-US" sz="3600" b="1" cap="none" spc="0" dirty="0">
              <a:ln w="0"/>
              <a:solidFill>
                <a:srgbClr val="A162D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Cambria Math" panose="02040503050406030204" pitchFamily="18" charset="0"/>
              <a:ea typeface="Cambria Math" panose="020405030504060302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ML_L_s105_s1_T2">
            <a:hlinkClick r:id="" action="ppaction://media"/>
            <a:extLst>
              <a:ext uri="{FF2B5EF4-FFF2-40B4-BE49-F238E27FC236}">
                <a16:creationId xmlns:a16="http://schemas.microsoft.com/office/drawing/2014/main" id="{121D06CD-7FEB-40CA-BCFD-9C28B66A93F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67657" y="1074736"/>
            <a:ext cx="10856686" cy="553436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CBE1777-0957-40BA-8685-6C3DE18232A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17480" y="0"/>
            <a:ext cx="1874520" cy="1197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63524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667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E1F1416-E324-41A6-9172-9D945EEA0A49}"/>
              </a:ext>
            </a:extLst>
          </p:cNvPr>
          <p:cNvSpPr/>
          <p:nvPr/>
        </p:nvSpPr>
        <p:spPr>
          <a:xfrm>
            <a:off x="5505133" y="248899"/>
            <a:ext cx="1181734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accent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</a:rPr>
              <a:t>Sagittal </a:t>
            </a:r>
            <a:r>
              <a:rPr lang="en-US" sz="2000" b="1" dirty="0">
                <a:ln w="0"/>
                <a:solidFill>
                  <a:schemeClr val="accent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Cambria Math" panose="02040503050406030204" pitchFamily="18" charset="0"/>
                <a:ea typeface="Cambria Math" panose="02040503050406030204" pitchFamily="18" charset="0"/>
                <a:cs typeface="Times New Roman" panose="02020603050405020304" pitchFamily="18" charset="0"/>
              </a:rPr>
              <a:t>L</a:t>
            </a:r>
            <a:endParaRPr lang="en-US" sz="3600" b="1" cap="none" spc="0" dirty="0">
              <a:ln w="0"/>
              <a:solidFill>
                <a:schemeClr val="accent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Cambria Math" panose="02040503050406030204" pitchFamily="18" charset="0"/>
              <a:ea typeface="Cambria Math" panose="020405030504060302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AP_L_s003_s1_T3">
            <a:hlinkClick r:id="" action="ppaction://media"/>
            <a:extLst>
              <a:ext uri="{FF2B5EF4-FFF2-40B4-BE49-F238E27FC236}">
                <a16:creationId xmlns:a16="http://schemas.microsoft.com/office/drawing/2014/main" id="{CB3870CD-DDC7-4A10-840C-530A2426BB6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70318" y="1077448"/>
            <a:ext cx="10851364" cy="553165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E285016-4379-4A19-A799-A0D71EFBE7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12666" y="0"/>
            <a:ext cx="1879334" cy="120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99710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534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141</Words>
  <Application>Microsoft Office PowerPoint</Application>
  <PresentationFormat>Widescreen</PresentationFormat>
  <Paragraphs>38</Paragraphs>
  <Slides>7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errahman Ouattas</dc:creator>
  <cp:lastModifiedBy>Abderrahman Ouattas</cp:lastModifiedBy>
  <cp:revision>5</cp:revision>
  <dcterms:created xsi:type="dcterms:W3CDTF">2021-09-09T17:13:15Z</dcterms:created>
  <dcterms:modified xsi:type="dcterms:W3CDTF">2021-10-04T22:15:11Z</dcterms:modified>
</cp:coreProperties>
</file>